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56" r:id="rId3"/>
    <p:sldId id="262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704" y="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1/06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6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6/2024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6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6/2024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6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6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1/0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s://doi.org/10.1016/j.jcjd.2019.01.007" TargetMode="Externa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s://doi.org/10.1016/j.jcjd.2019.01.007" TargetMode="Externa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7504" y="5592722"/>
            <a:ext cx="8280920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Byndloss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06198-1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American Diabetes Association and the European Association for the Study of Diabetes 2024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07504" y="188640"/>
            <a:ext cx="3024336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Microecological and physiological differences along the gastrointestinal tract</a:t>
            </a:r>
            <a:endParaRPr lang="en-GB" sz="20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F07BDB2-87C3-E134-FD02-77111E68ADC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07904" y="188640"/>
            <a:ext cx="4320480" cy="58669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79512" y="5877272"/>
            <a:ext cx="7128792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600" dirty="0"/>
          </a:p>
          <a:p>
            <a:r>
              <a:rPr lang="en-GB" dirty="0" err="1"/>
              <a:t>Byndloss</a:t>
            </a:r>
            <a:r>
              <a:rPr lang="en-GB" dirty="0"/>
              <a:t> et al (2024) </a:t>
            </a:r>
            <a:r>
              <a:rPr lang="en-GB" dirty="0" err="1"/>
              <a:t>Diabetologia</a:t>
            </a:r>
            <a:r>
              <a:rPr lang="en-GB" dirty="0"/>
              <a:t> DOI 10.1007/s00125-024-06198-1</a:t>
            </a:r>
            <a:endParaRPr lang="en-GB" dirty="0">
              <a:solidFill>
                <a:srgbClr val="FF0000"/>
              </a:solidFill>
            </a:endParaRPr>
          </a:p>
          <a:p>
            <a:r>
              <a:rPr lang="en-US" sz="1200" dirty="0"/>
              <a:t>© 2019 Canadian Diabetes Association. Adapted from Caesar (</a:t>
            </a:r>
            <a:r>
              <a:rPr lang="en-US" sz="1200" dirty="0">
                <a:hlinkClick r:id="rId2"/>
              </a:rPr>
              <a:t>https://doi.org/10.1016/j.jcjd.2019.01.007</a:t>
            </a:r>
            <a:r>
              <a:rPr lang="en-US" sz="1200" dirty="0"/>
              <a:t>)</a:t>
            </a:r>
          </a:p>
          <a:p>
            <a:r>
              <a:rPr lang="en-US" sz="1200" dirty="0"/>
              <a:t>with permission from Elsevier</a:t>
            </a:r>
            <a:endParaRPr lang="en-GB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251520" y="272842"/>
            <a:ext cx="396044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Gut microbiota metabolites and </a:t>
            </a:r>
            <a:r>
              <a:rPr lang="en-US" sz="2000" b="1" dirty="0" err="1"/>
              <a:t>signalling</a:t>
            </a:r>
            <a:r>
              <a:rPr lang="en-US" sz="2000" b="1" dirty="0"/>
              <a:t> molecules linked to glucose metabolism and type 2 diabetes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FB1792D-8FAD-7E8E-1CC6-AFB51EFF058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23928" y="263694"/>
            <a:ext cx="4248472" cy="5652442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79512" y="5869721"/>
            <a:ext cx="680982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Byndloss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4)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abetologia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DOI 10.1007/s00125-024-06198-1</a:t>
            </a: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2019 Canadian Diabetes Association. Adapted from Caesar (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2"/>
              </a:rPr>
              <a:t>https://doi.org/10.1016/j.jcjd.2019.01.007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with permission from Elsevier</a:t>
            </a: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95536" y="332656"/>
            <a:ext cx="82089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Gut microbiota interactions with glucose-lowering medications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CC74E0D-4B11-49B5-4512-8BA40A081C2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47664" y="988954"/>
            <a:ext cx="5889650" cy="48883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59605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7</Words>
  <Application>Microsoft Office PowerPoint</Application>
  <PresentationFormat>On-screen Show (4:3)</PresentationFormat>
  <Paragraphs>17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50</cp:revision>
  <dcterms:created xsi:type="dcterms:W3CDTF">2016-06-15T12:53:43Z</dcterms:created>
  <dcterms:modified xsi:type="dcterms:W3CDTF">2024-06-11T16:18:38Z</dcterms:modified>
</cp:coreProperties>
</file>